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4" r:id="rId2"/>
    <p:sldId id="265" r:id="rId3"/>
    <p:sldId id="266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8"/>
    <p:restoredTop sz="94663"/>
  </p:normalViewPr>
  <p:slideViewPr>
    <p:cSldViewPr snapToGrid="0" snapToObjects="1">
      <p:cViewPr varScale="1">
        <p:scale>
          <a:sx n="118" d="100"/>
          <a:sy n="118" d="100"/>
        </p:scale>
        <p:origin x="34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540592-818A-154B-B174-710C66046A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679C789-BAB2-D940-BF1B-9FD00EDD68E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40BC40-B1D2-0B46-B482-0A6092CD12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75E64-A8E2-D841-9911-A3C35BE49CCD}" type="datetimeFigureOut">
              <a:rPr lang="en-US" smtClean="0"/>
              <a:t>7/7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4FCA8B-85B2-3543-921B-3B4282F2DF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06427A-F07A-DE4D-A6E9-E0C7899FF6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2E3B6-6DF5-2648-ADCE-EDFDF66A49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97469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666EB5-0E16-A943-B2C4-6F0384ADC6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706F5D-3CBA-7543-9558-B3016DEFDF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66B59B-AD77-4C44-9009-7EF3D7852C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75E64-A8E2-D841-9911-A3C35BE49CCD}" type="datetimeFigureOut">
              <a:rPr lang="en-US" smtClean="0"/>
              <a:t>7/7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C1121D-F946-DD41-B010-451DA854F0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879CB0-9A93-7148-B7B7-5334EABE22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2E3B6-6DF5-2648-ADCE-EDFDF66A49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43349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B51EDBB-D705-974A-AD04-AC6D07E707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B765915-B805-584E-AFAA-1F12BCE35D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B5EE57-8A04-CE4B-B962-C683A808CC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75E64-A8E2-D841-9911-A3C35BE49CCD}" type="datetimeFigureOut">
              <a:rPr lang="en-US" smtClean="0"/>
              <a:t>7/7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24B414-BCC2-4947-B006-2568C63DCD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65AE3D-1630-F842-ABC0-87BBE1DB6D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2E3B6-6DF5-2648-ADCE-EDFDF66A49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3713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85B6B6-DA93-CB41-A30D-5F749F9B70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8326B3-B906-064F-8784-E8584E7E304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30204F-0ADF-0E47-8F08-08ACF0A859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75E64-A8E2-D841-9911-A3C35BE49CCD}" type="datetimeFigureOut">
              <a:rPr lang="en-US" smtClean="0"/>
              <a:t>7/7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4349FB-789C-AC46-B9F0-18A6FE5F2D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EA82D3-BE39-B146-BBFD-666434436C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2E3B6-6DF5-2648-ADCE-EDFDF66A49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64114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9649C2-C1C3-4949-BA72-875A62F661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F009C1-7A12-394F-AE16-5CE1C025A8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2E65E7-6EB7-564A-94D5-8C255FD432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75E64-A8E2-D841-9911-A3C35BE49CCD}" type="datetimeFigureOut">
              <a:rPr lang="en-US" smtClean="0"/>
              <a:t>7/7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08754B-A357-0846-8445-8A8213682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EACC09-7C28-E44B-97BA-A0A08269B1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2E3B6-6DF5-2648-ADCE-EDFDF66A49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711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726EE6-1D97-6C4B-952C-A3B0620517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302330-18CD-864F-818F-00905B6A733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B0143C1-73C9-3B41-A3C5-61407F02A5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AD3852-C6B3-3D4C-BAEE-B6CA95B5E4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75E64-A8E2-D841-9911-A3C35BE49CCD}" type="datetimeFigureOut">
              <a:rPr lang="en-US" smtClean="0"/>
              <a:t>7/7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7B3CCB-DD32-9B45-8C56-F23E7A6FF4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99BA077-F30B-DD47-8288-F5177E8DBF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2E3B6-6DF5-2648-ADCE-EDFDF66A49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12433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8A660E-A3B9-6F4E-8E59-8D12FC6A7B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1D3335-D81C-5D4B-B284-6D13428329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3B8855-5346-7A4B-8716-1E1E9754F4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B5F3C7E-B8DC-EE49-8D2C-03D5E98DCCA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995B297-BFCE-F84F-A32D-66B18BF6005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F8AB089-81C5-9E49-9A1E-1E922CE7FE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75E64-A8E2-D841-9911-A3C35BE49CCD}" type="datetimeFigureOut">
              <a:rPr lang="en-US" smtClean="0"/>
              <a:t>7/7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2E52904-743E-1645-A6A7-7C2ED5025D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79E8A91-440E-1041-BF5D-DEFCC72F56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2E3B6-6DF5-2648-ADCE-EDFDF66A49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9817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1132DD-8D9F-EC46-8E40-60463F8214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6E10318-C875-0043-8972-6393728ECD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75E64-A8E2-D841-9911-A3C35BE49CCD}" type="datetimeFigureOut">
              <a:rPr lang="en-US" smtClean="0"/>
              <a:t>7/7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FB69367-9BD6-E241-A259-9F3F6AA697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6E43BB9-3FEF-7B4A-BB80-47D9A00F23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2E3B6-6DF5-2648-ADCE-EDFDF66A49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9875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85F5DA2-9F9F-EA41-B405-DA0794840F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75E64-A8E2-D841-9911-A3C35BE49CCD}" type="datetimeFigureOut">
              <a:rPr lang="en-US" smtClean="0"/>
              <a:t>7/7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BA55685-EE9D-7944-8572-E87F9906F6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6A936D8-73BF-DF4C-A1E5-8E74915BB4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2E3B6-6DF5-2648-ADCE-EDFDF66A49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2306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93FAA6-F635-0544-831E-FD564597EF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50B4F3-59DE-4E45-8E36-2956DA96AC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CE59BF6-B6EE-DC44-B40C-83BA790470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AD0C84C-AE04-D54B-9227-DE6B8F9CB2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75E64-A8E2-D841-9911-A3C35BE49CCD}" type="datetimeFigureOut">
              <a:rPr lang="en-US" smtClean="0"/>
              <a:t>7/7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D8A83F-0EFA-0645-9355-7734373980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DDA7C6-E886-E440-ABC1-FC129DC047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2E3B6-6DF5-2648-ADCE-EDFDF66A49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1596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E5EFF9-B042-C943-8EA0-26B0300B3B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46AB62B-9938-F243-A6BB-1B5288F8C24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222EDCF-9194-AB4B-83EF-8F2AB53551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8BD1FBC-93E0-AB46-9A4B-E12DB5DEEE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75E64-A8E2-D841-9911-A3C35BE49CCD}" type="datetimeFigureOut">
              <a:rPr lang="en-US" smtClean="0"/>
              <a:t>7/7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080098-3795-B54D-B220-1BC977DED4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692F66-0837-CC42-812B-13CE3B7669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2E3B6-6DF5-2648-ADCE-EDFDF66A49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9536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1B3BFFB-D8A5-774F-8F01-EFCD9E6E1E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7090637-9045-9B46-88C6-D777B74FF3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5663E3-13AD-AC45-9F87-6706FDA0BE3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F75E64-A8E2-D841-9911-A3C35BE49CCD}" type="datetimeFigureOut">
              <a:rPr lang="en-US" smtClean="0"/>
              <a:t>7/7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6D8477-E437-A84D-AE98-12D905C50F6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3248EE-18A4-FC4E-BA77-AC12BF43C71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82E3B6-6DF5-2648-ADCE-EDFDF66A49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35797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au 5">
            <a:extLst>
              <a:ext uri="{FF2B5EF4-FFF2-40B4-BE49-F238E27FC236}">
                <a16:creationId xmlns:a16="http://schemas.microsoft.com/office/drawing/2014/main" id="{2AF19792-E5F3-495A-8AB8-0FBDDD6EDD91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771261" y="457201"/>
          <a:ext cx="8649478" cy="619767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62389">
                  <a:extLst>
                    <a:ext uri="{9D8B030D-6E8A-4147-A177-3AD203B41FA5}">
                      <a16:colId xmlns:a16="http://schemas.microsoft.com/office/drawing/2014/main" val="2885378958"/>
                    </a:ext>
                  </a:extLst>
                </a:gridCol>
                <a:gridCol w="1202988">
                  <a:extLst>
                    <a:ext uri="{9D8B030D-6E8A-4147-A177-3AD203B41FA5}">
                      <a16:colId xmlns:a16="http://schemas.microsoft.com/office/drawing/2014/main" val="1229770995"/>
                    </a:ext>
                  </a:extLst>
                </a:gridCol>
                <a:gridCol w="409016">
                  <a:extLst>
                    <a:ext uri="{9D8B030D-6E8A-4147-A177-3AD203B41FA5}">
                      <a16:colId xmlns:a16="http://schemas.microsoft.com/office/drawing/2014/main" val="1803079440"/>
                    </a:ext>
                  </a:extLst>
                </a:gridCol>
                <a:gridCol w="3236036">
                  <a:extLst>
                    <a:ext uri="{9D8B030D-6E8A-4147-A177-3AD203B41FA5}">
                      <a16:colId xmlns:a16="http://schemas.microsoft.com/office/drawing/2014/main" val="3784013509"/>
                    </a:ext>
                  </a:extLst>
                </a:gridCol>
                <a:gridCol w="577434">
                  <a:extLst>
                    <a:ext uri="{9D8B030D-6E8A-4147-A177-3AD203B41FA5}">
                      <a16:colId xmlns:a16="http://schemas.microsoft.com/office/drawing/2014/main" val="1293948652"/>
                    </a:ext>
                  </a:extLst>
                </a:gridCol>
                <a:gridCol w="806001">
                  <a:extLst>
                    <a:ext uri="{9D8B030D-6E8A-4147-A177-3AD203B41FA5}">
                      <a16:colId xmlns:a16="http://schemas.microsoft.com/office/drawing/2014/main" val="3529847779"/>
                    </a:ext>
                  </a:extLst>
                </a:gridCol>
                <a:gridCol w="673672">
                  <a:extLst>
                    <a:ext uri="{9D8B030D-6E8A-4147-A177-3AD203B41FA5}">
                      <a16:colId xmlns:a16="http://schemas.microsoft.com/office/drawing/2014/main" val="2416558216"/>
                    </a:ext>
                  </a:extLst>
                </a:gridCol>
                <a:gridCol w="781942">
                  <a:extLst>
                    <a:ext uri="{9D8B030D-6E8A-4147-A177-3AD203B41FA5}">
                      <a16:colId xmlns:a16="http://schemas.microsoft.com/office/drawing/2014/main" val="4034277535"/>
                    </a:ext>
                  </a:extLst>
                </a:gridCol>
              </a:tblGrid>
              <a:tr h="119186"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in </a:t>
                      </a:r>
                      <a:r>
                        <a:rPr lang="fr-CA" sz="7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oD</a:t>
                      </a:r>
                      <a:endParaRPr lang="fr-CA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uthor(s)</a:t>
                      </a:r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ar </a:t>
                      </a:r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tle</a:t>
                      </a:r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ond. </a:t>
                      </a:r>
                      <a:r>
                        <a:rPr lang="fr-CA" sz="7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oD</a:t>
                      </a:r>
                      <a:endParaRPr lang="fr-CA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ournal Type</a:t>
                      </a:r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ne</a:t>
                      </a:r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gumentation</a:t>
                      </a:r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0667753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6944587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 Nature-</a:t>
                      </a:r>
                      <a:r>
                        <a:rPr lang="fr-CA" sz="7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rture</a:t>
                      </a:r>
                      <a:endParaRPr lang="fr-CA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or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Potential of Epigenetics to Transform Conceptions of Phenotype Development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ltidiscipli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9958477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ablonka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ltural Epigenetic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c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78245604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loni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om Boundary-Work to Boundary Object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c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92466492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djev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marck's Legac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7948243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ppé and Landecker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w the Genome Got a Life Span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08132897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loni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redity</a:t>
                      </a:r>
                      <a:r>
                        <a:rPr lang="fr-CA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2.0*</a:t>
                      </a:r>
                      <a:endParaRPr lang="fr-CA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S</a:t>
                      </a:r>
                      <a:endParaRPr lang="fr-CA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85771197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iewöhner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alizing Biology Through Colaboration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12787273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nofsk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 Conceptual Revolution Limited by Disciplinary Division*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ublic Health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2977891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ayer and Non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hropology Meets Epigenetic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 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hrop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13752133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teson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4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volution, Epigenetics and Cooperation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3372886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rner and Overton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4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s, Evolution, and Embodiment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omic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0081213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loni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4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w Biology Became Soci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c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3682790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ndecker and Panofsk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om Social Structure to Gene Regulation, and Back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c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57773495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k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Epigenome and Nature/Nurture Reunification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hrop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70766420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uthman and Mansfiled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2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Implications of Environmental Epigenetic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ograph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18269897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ning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8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 Emerging Challenge to Genetic Determinism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c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5833815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rbano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s and Genetic Determinism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sto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83878926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22665994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 Biologization</a:t>
                      </a:r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rner and Overton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hy Epigenetics Invalidates All Models Involving Genetic Reduction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ltidiscipli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6398173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ckliter and Witherington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wards a Truly Developmental Epigenetic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ltidiscipli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0036630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ackman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Challenges of New Biopsychosocialitie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c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83227051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ung et al.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 Science of Social Science?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c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4520023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epfer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here Does Sexual Orientation Come From?*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inist Studie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0100909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ndecker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Social as Signal in the Body of Chromatin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c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80579792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k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rehending the Body in the Era of the Epigenome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hrop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67163584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born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tting Under Performance's Skin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terary Studie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84505273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valastog and Damjanovicova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s, Society, and Bio-objects*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 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cin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19055492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arin et al.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Reproduction of Habitus through Intracellular and Social Environment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811319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vi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4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thinking the Materiality of Feminist Political Action through Epigenetic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inist Studie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9820473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loni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4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ogy without Biologism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c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76328454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oniolo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 An Account of Identity Necessary for Bioethics?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ilosoph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17121833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k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Lure of the Epigenome*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cin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92871663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oniolo and Testa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2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Identity of Living Being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ilosoph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68157244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iewöhner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1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mbedded Bodies and the Molecularisation of Biography and Milieu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 (Emp) 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924337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padopoulo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1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Imaginary of Plasticit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c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2383318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ndecker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1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od as Exposur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48539356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uzawa and Sweet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9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s and the Embodiement of Race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 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6479711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25997968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 Public </a:t>
                      </a:r>
                      <a:r>
                        <a:rPr lang="fr-CA" sz="7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lth</a:t>
                      </a:r>
                      <a:r>
                        <a:rPr lang="fr-CA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fr-CA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Bride and Koehl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agining Roles for Epigenetics in Health Promotion Research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cin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7863094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bs-Orm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s Revisioned*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cial Work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44482115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oas Reis and Oliveira Naves</a:t>
                      </a:r>
                      <a:endParaRPr lang="pt-B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s and Environmental Bioethic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w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65564133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k and Kobor</a:t>
                      </a:r>
                      <a:endParaRPr lang="fr-CA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Potential of Social Epigenetics for Child Health Polic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 9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ublic Health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353724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upras et al.</a:t>
                      </a:r>
                      <a:endParaRPr lang="fr-CA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4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s and the Environment in Bioethic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ethic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8858637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abasenche</a:t>
                      </a:r>
                      <a:r>
                        <a:rPr lang="fr-CA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nd Skinner</a:t>
                      </a:r>
                      <a:endParaRPr lang="fr-CA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4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DT, Epigenetic Harm, and Transgenerational Environmental Justice*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ublic Health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4487426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bs-Orme</a:t>
                      </a:r>
                      <a:endParaRPr lang="fr-CA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s and the Social Work Imperative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cial Work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47980167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iculescu</a:t>
                      </a:r>
                      <a:endParaRPr lang="fr-CA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1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ould Obesity-Prevention Policies be Reconsidered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ublic Health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9123113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rake and Liu</a:t>
                      </a:r>
                      <a:endParaRPr lang="fr-CA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0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generational Transmission of Programmed Effect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03816126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thstein</a:t>
                      </a:r>
                      <a:r>
                        <a:rPr lang="fr-CA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t al.</a:t>
                      </a:r>
                      <a:endParaRPr lang="fr-CA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9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Ghost in our Gene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 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cin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29672804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ossdorf et al.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8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s for Ecologist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64486826"/>
                  </a:ext>
                </a:extLst>
              </a:tr>
              <a:tr h="11918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gl et al.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w Understanding of Epigenetics*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 5</a:t>
                      </a:r>
                      <a:endParaRPr lang="fr-CA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ve</a:t>
                      </a:r>
                      <a:endParaRPr lang="fr-CA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29" marR="4829" marT="4829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5787203"/>
                  </a:ext>
                </a:extLst>
              </a:tr>
            </a:tbl>
          </a:graphicData>
        </a:graphic>
      </p:graphicFrame>
      <p:sp>
        <p:nvSpPr>
          <p:cNvPr id="8" name="Rectangle 7">
            <a:extLst>
              <a:ext uri="{FF2B5EF4-FFF2-40B4-BE49-F238E27FC236}">
                <a16:creationId xmlns:a16="http://schemas.microsoft.com/office/drawing/2014/main" id="{FF455D64-D4C5-48C9-AFCC-B5FD21392B74}"/>
              </a:ext>
            </a:extLst>
          </p:cNvPr>
          <p:cNvSpPr/>
          <p:nvPr/>
        </p:nvSpPr>
        <p:spPr>
          <a:xfrm>
            <a:off x="1701285" y="91161"/>
            <a:ext cx="905069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defRPr/>
            </a:pP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ppendix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fr-F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st of </a:t>
            </a:r>
            <a:r>
              <a:rPr lang="fr-F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lected</a:t>
            </a:r>
            <a:r>
              <a:rPr lang="fr-F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ublications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062536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>
            <a:extLst>
              <a:ext uri="{FF2B5EF4-FFF2-40B4-BE49-F238E27FC236}">
                <a16:creationId xmlns:a16="http://schemas.microsoft.com/office/drawing/2014/main" id="{826206AF-AD9E-4639-9A30-D3CF4816B436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743270" y="233285"/>
          <a:ext cx="8705461" cy="642875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68620">
                  <a:extLst>
                    <a:ext uri="{9D8B030D-6E8A-4147-A177-3AD203B41FA5}">
                      <a16:colId xmlns:a16="http://schemas.microsoft.com/office/drawing/2014/main" val="3131830069"/>
                    </a:ext>
                  </a:extLst>
                </a:gridCol>
                <a:gridCol w="1210773">
                  <a:extLst>
                    <a:ext uri="{9D8B030D-6E8A-4147-A177-3AD203B41FA5}">
                      <a16:colId xmlns:a16="http://schemas.microsoft.com/office/drawing/2014/main" val="195847477"/>
                    </a:ext>
                  </a:extLst>
                </a:gridCol>
                <a:gridCol w="411663">
                  <a:extLst>
                    <a:ext uri="{9D8B030D-6E8A-4147-A177-3AD203B41FA5}">
                      <a16:colId xmlns:a16="http://schemas.microsoft.com/office/drawing/2014/main" val="2283120717"/>
                    </a:ext>
                  </a:extLst>
                </a:gridCol>
                <a:gridCol w="3256980">
                  <a:extLst>
                    <a:ext uri="{9D8B030D-6E8A-4147-A177-3AD203B41FA5}">
                      <a16:colId xmlns:a16="http://schemas.microsoft.com/office/drawing/2014/main" val="2182530497"/>
                    </a:ext>
                  </a:extLst>
                </a:gridCol>
                <a:gridCol w="581172">
                  <a:extLst>
                    <a:ext uri="{9D8B030D-6E8A-4147-A177-3AD203B41FA5}">
                      <a16:colId xmlns:a16="http://schemas.microsoft.com/office/drawing/2014/main" val="3469943464"/>
                    </a:ext>
                  </a:extLst>
                </a:gridCol>
                <a:gridCol w="811218">
                  <a:extLst>
                    <a:ext uri="{9D8B030D-6E8A-4147-A177-3AD203B41FA5}">
                      <a16:colId xmlns:a16="http://schemas.microsoft.com/office/drawing/2014/main" val="3942924072"/>
                    </a:ext>
                  </a:extLst>
                </a:gridCol>
                <a:gridCol w="678033">
                  <a:extLst>
                    <a:ext uri="{9D8B030D-6E8A-4147-A177-3AD203B41FA5}">
                      <a16:colId xmlns:a16="http://schemas.microsoft.com/office/drawing/2014/main" val="1971884444"/>
                    </a:ext>
                  </a:extLst>
                </a:gridCol>
                <a:gridCol w="787002">
                  <a:extLst>
                    <a:ext uri="{9D8B030D-6E8A-4147-A177-3AD203B41FA5}">
                      <a16:colId xmlns:a16="http://schemas.microsoft.com/office/drawing/2014/main" val="3664208745"/>
                    </a:ext>
                  </a:extLst>
                </a:gridCol>
              </a:tblGrid>
              <a:tr h="119051"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 Reproduction</a:t>
                      </a:r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nsfield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 Plasticity, Temporality and New Thresholds of Fetal Life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 (Emp) 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25530541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n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Ethics of Postponed Fatherhood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 9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inist Studie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646349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y et al.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Epigenetic Effects of Assisted Reproductive Technologie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 9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cin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1288280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ield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 Signals of How Social Disadvantage 'Gets Under the Skin'*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omic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7208002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enney and Müller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f Rats and Women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, 9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2627804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icholson and Nicholson</a:t>
                      </a:r>
                      <a:endParaRPr lang="fr-CA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 Used to Have Two Parents Now I Have Three?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w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74206378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hite and Wastel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s Prematurely Born(e)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 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cial Work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1406266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allack and Thornburg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velopmental Origins, Epigenetics and Equity*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cin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37730262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ronimu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tting the Epigenome Out of the Bottle…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 9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ublic Health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5007558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1480645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 Political Theory</a:t>
                      </a:r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tkus and Kolme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gral Ecology, Epigenetics and the Common Good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 9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06727058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'hamdi et al.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dge me, Help my Bab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 4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ethic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1158765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’hamdi et al.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ponsibility in the Age of DOHaD and Epigenetic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cin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8882143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thstein et al.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nsgenerational Epigenetics and Environmental Justice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 9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omic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28862559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ars and d'Abramo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lth, Wealth and Behavioural Change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, 9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omic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1600667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apperino and Testa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Epigenomic Self in Personalized Medicine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c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0914429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upras and Ravitsk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Ambiguous Nature of Epigenetic Responsibilit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 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ethic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3435785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vers and Changeux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active Epigenesis and Ethical Innovation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9930095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l Savio et al.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s and Future Generation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 4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ethic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14107488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ver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 We Be Epigenetically Proactive?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99723173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loni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s for the Social Science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8217736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adwick and O'Connor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s and Personalized Medicin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cin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86247671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i et al.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cial Epigenetics and Equality of Opportunit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 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ethic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1091888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pleton et al.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quity in Public Health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ublic Health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 (Emp) 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0037699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dlund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2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 Responsibilit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 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ethic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046659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hrader-Frechett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2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king Action on Developmental Toxicity*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ublic Health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2592833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thstein et al.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9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ical Implications of Epigenetics Research*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85871778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2328059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 Legal Proceedings</a:t>
                      </a:r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ndenburgh et al.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Implications of Epigenetics for Environmental Law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w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7666315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ubach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s and Toxic Tort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w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4442937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unther and Felthou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s and the Law*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w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60289814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matea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‘Biologizing’ Psychopath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 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w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9954689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thstein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 Exceptionalism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 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w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1500274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rker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2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nning Bisphenol A in the United States and Canada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w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28049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han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0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serving Human Potential as Freedom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w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62736731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ener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0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nsgenerational Tort Liability for Epigenetic Disease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w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7955040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05322374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 Discrimination</a:t>
                      </a:r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ulnier and Dupra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ce in the Postgenomic Era*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ethic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1766000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loni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ce in an Epigenetic Time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c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9024705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aham et al.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s and Russia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ilosoph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42539135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nsfield and Guthman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 Lif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 4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ograph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810866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atz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Biological Inferiority of the Undeserving Poor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cial Work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34748784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llivan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heriting Racist Disparities in Health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ilosoph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48508886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uthman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2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oing Justice to Bodies?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 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ograph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4954625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nsfield and Guthman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2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ce and the New Epigenetic Biopolitics of Environmental Health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 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2805160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93798485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 Privacy Protection</a:t>
                      </a:r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oly et al.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e Data Sharing and Privacy Protection Mutually Exclusive?*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5761244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ke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vacy in Epigenetics*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ve (Emp) 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0500262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yke et al.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ome Data Releas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omic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ve (Emp) 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7965376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win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ical Issues in Epigenetic Testing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w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3050108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oly et al.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isk of Re-identification of Epigenetic Methylation Data*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omic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64607272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oma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s and Child Psychiat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 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w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8175998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r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velopments in Genetic and Epigenetic Data Protection…  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w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78931659"/>
                  </a:ext>
                </a:extLst>
              </a:tr>
              <a:tr h="119051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ilibert et al.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4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hylation Array Data Can Simultaneously Identify Individuals and …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omic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ve (</a:t>
                      </a:r>
                      <a:r>
                        <a:rPr lang="fr-CA" sz="7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mp</a:t>
                      </a:r>
                      <a:r>
                        <a:rPr lang="fr-CA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 </a:t>
                      </a:r>
                      <a:endParaRPr lang="fr-CA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40" marR="4740" marT="474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6280377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737178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>
            <a:extLst>
              <a:ext uri="{FF2B5EF4-FFF2-40B4-BE49-F238E27FC236}">
                <a16:creationId xmlns:a16="http://schemas.microsoft.com/office/drawing/2014/main" id="{9FD64B1A-2023-4031-8442-4FD3855027A3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738603" y="223935"/>
          <a:ext cx="8664930" cy="27058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64110">
                  <a:extLst>
                    <a:ext uri="{9D8B030D-6E8A-4147-A177-3AD203B41FA5}">
                      <a16:colId xmlns:a16="http://schemas.microsoft.com/office/drawing/2014/main" val="1705358616"/>
                    </a:ext>
                  </a:extLst>
                </a:gridCol>
                <a:gridCol w="1205136">
                  <a:extLst>
                    <a:ext uri="{9D8B030D-6E8A-4147-A177-3AD203B41FA5}">
                      <a16:colId xmlns:a16="http://schemas.microsoft.com/office/drawing/2014/main" val="740971946"/>
                    </a:ext>
                  </a:extLst>
                </a:gridCol>
                <a:gridCol w="409746">
                  <a:extLst>
                    <a:ext uri="{9D8B030D-6E8A-4147-A177-3AD203B41FA5}">
                      <a16:colId xmlns:a16="http://schemas.microsoft.com/office/drawing/2014/main" val="3178515285"/>
                    </a:ext>
                  </a:extLst>
                </a:gridCol>
                <a:gridCol w="3241817">
                  <a:extLst>
                    <a:ext uri="{9D8B030D-6E8A-4147-A177-3AD203B41FA5}">
                      <a16:colId xmlns:a16="http://schemas.microsoft.com/office/drawing/2014/main" val="2269655577"/>
                    </a:ext>
                  </a:extLst>
                </a:gridCol>
                <a:gridCol w="578465">
                  <a:extLst>
                    <a:ext uri="{9D8B030D-6E8A-4147-A177-3AD203B41FA5}">
                      <a16:colId xmlns:a16="http://schemas.microsoft.com/office/drawing/2014/main" val="1742074796"/>
                    </a:ext>
                  </a:extLst>
                </a:gridCol>
                <a:gridCol w="807441">
                  <a:extLst>
                    <a:ext uri="{9D8B030D-6E8A-4147-A177-3AD203B41FA5}">
                      <a16:colId xmlns:a16="http://schemas.microsoft.com/office/drawing/2014/main" val="2113628474"/>
                    </a:ext>
                  </a:extLst>
                </a:gridCol>
                <a:gridCol w="674876">
                  <a:extLst>
                    <a:ext uri="{9D8B030D-6E8A-4147-A177-3AD203B41FA5}">
                      <a16:colId xmlns:a16="http://schemas.microsoft.com/office/drawing/2014/main" val="1230208338"/>
                    </a:ext>
                  </a:extLst>
                </a:gridCol>
                <a:gridCol w="783339">
                  <a:extLst>
                    <a:ext uri="{9D8B030D-6E8A-4147-A177-3AD203B41FA5}">
                      <a16:colId xmlns:a16="http://schemas.microsoft.com/office/drawing/2014/main" val="597042679"/>
                    </a:ext>
                  </a:extLst>
                </a:gridCol>
              </a:tblGrid>
              <a:tr h="171074"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 Know. Translation</a:t>
                      </a:r>
                      <a:endParaRPr lang="fr-CA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ntecost and Cousin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 and Microbial Imaginaries in Post-Apartheid Cape Town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 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ograph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09153679"/>
                  </a:ext>
                </a:extLst>
              </a:tr>
              <a:tr h="133820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üller et al.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Biosocial Genome?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 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14205091"/>
                  </a:ext>
                </a:extLst>
              </a:tr>
              <a:tr h="133820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djev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s, Representation and Societ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88543996"/>
                  </a:ext>
                </a:extLst>
              </a:tr>
              <a:tr h="133820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uang and King</a:t>
                      </a:r>
                      <a:endParaRPr lang="fr-CA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s Changes Nothing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 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ethic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73873690"/>
                  </a:ext>
                </a:extLst>
              </a:tr>
              <a:tr h="133820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upras et al.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political Barriers to a Potterian Bioethics*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 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ethic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923456"/>
                  </a:ext>
                </a:extLst>
              </a:tr>
              <a:tr h="133820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ichmann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Origins and Evolution of a Fashionable Topic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7576268"/>
                  </a:ext>
                </a:extLst>
              </a:tr>
              <a:tr h="133820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upras and Ravitsk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s in the Neoliberal 'Regime of Truth'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 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ethic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6346154"/>
                  </a:ext>
                </a:extLst>
              </a:tr>
              <a:tr h="259866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ppé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s, Media Coverage, and Parent Responsibilities in the Post-Genomic Era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 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omic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ectic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19325050"/>
                  </a:ext>
                </a:extLst>
              </a:tr>
              <a:tr h="133820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oly et al.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rker Than You Think?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omic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1264844"/>
                  </a:ext>
                </a:extLst>
              </a:tr>
              <a:tr h="133820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ckersgil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stemic Modesty, Ostentatiousness and the Uncertainties of Epigenetic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c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 (Emp) 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38671704"/>
                  </a:ext>
                </a:extLst>
              </a:tr>
              <a:tr h="133820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bison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Political Implications of Epigenetic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 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ve (Emp) 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8338770"/>
                  </a:ext>
                </a:extLst>
              </a:tr>
              <a:tr h="133820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ddleton</a:t>
                      </a:r>
                      <a:endParaRPr lang="fr-CA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s and Poet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terary Studie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27876887"/>
                  </a:ext>
                </a:extLst>
              </a:tr>
              <a:tr h="133820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elmach and Nerlich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aphors in Search of a Target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 (Emp) 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650443"/>
                  </a:ext>
                </a:extLst>
              </a:tr>
              <a:tr h="133820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aggoner and Uller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 Determinism in Science and Societ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2802794"/>
                  </a:ext>
                </a:extLst>
              </a:tr>
              <a:tr h="133820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uengst et al.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4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ving Epigenetics Before its Time*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 7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omic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63455142"/>
                  </a:ext>
                </a:extLst>
              </a:tr>
              <a:tr h="133820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loni and Testa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4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rutinizing the Epigenetic Revolution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istic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79865738"/>
                  </a:ext>
                </a:extLst>
              </a:tr>
              <a:tr h="133820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ckersgil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4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roscience, Epigenetics and the Intergenerational Transmission of Social Life*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ciolog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34918348"/>
                  </a:ext>
                </a:extLst>
              </a:tr>
              <a:tr h="133820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ckersgill et al.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pping the New Molecular Landscape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al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1458320"/>
                  </a:ext>
                </a:extLst>
              </a:tr>
              <a:tr h="133820">
                <a:tc>
                  <a:txBody>
                    <a:bodyPr/>
                    <a:lstStyle/>
                    <a:p>
                      <a:pPr algn="l" fontAlgn="b"/>
                      <a:endParaRPr lang="fr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lwinski</a:t>
                      </a:r>
                      <a:endParaRPr lang="fr-CA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3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 New Genetics or an Epiphenomenon?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S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autionary</a:t>
                      </a:r>
                      <a:endParaRPr lang="fr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7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lexive</a:t>
                      </a:r>
                      <a:r>
                        <a:rPr lang="fr-CA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fr-CA" sz="7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mp</a:t>
                      </a:r>
                      <a:r>
                        <a:rPr lang="fr-CA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 </a:t>
                      </a:r>
                      <a:endParaRPr lang="fr-CA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81" marR="6581" marT="6581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7965796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72279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716</Words>
  <Application>Microsoft Macintosh PowerPoint</Application>
  <PresentationFormat>Widescreen</PresentationFormat>
  <Paragraphs>83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gio Sismondo</dc:creator>
  <cp:lastModifiedBy>Sergio Sismondo</cp:lastModifiedBy>
  <cp:revision>1</cp:revision>
  <dcterms:created xsi:type="dcterms:W3CDTF">2019-07-07T16:12:45Z</dcterms:created>
  <dcterms:modified xsi:type="dcterms:W3CDTF">2019-07-07T16:14:56Z</dcterms:modified>
</cp:coreProperties>
</file>